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3ECF948-2E1B-4031-8178-3A68BC988C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873ED957-6BD0-40CF-95F3-8E57A3D3942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2FB3A25-A8F0-4FA6-B662-F1A52A8F6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F63269F-EEC8-43B0-8C87-9FC36220C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598E6FE-0C92-46FC-9BB8-9A109C64F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2675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FE99FE8-0F3E-44C2-BC52-F993BC91C0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BF9CD705-11E5-4FF4-8312-3042E75F02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72D3C700-CF66-4A02-A222-AA376E4D8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649CF2D-9620-4FE4-8D46-C736DF545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AC5DDA3-852B-4776-A100-49847663A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1054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01257FA4-5292-49F5-B9D8-8C830F22AE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F77C4E8C-37C0-488E-8463-DF0CAC16EE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17B0AFA-6A74-4905-8578-0C2FBE5F8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8D130B8-EEB3-4436-904A-CD3DA16EB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6958CB8-4EFC-4C67-A3C7-A6CF6676A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3500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3F131B9-2074-4FDF-ADBF-D4FF958FD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F6E8A765-A950-4386-BA70-20D83B56B9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944D5E3-37C8-4E9A-A2F6-B308C5870E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21B28901-6850-4976-A7A8-8971C8728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2EA717D1-C1F6-4407-8A4E-23EF54A47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6161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2710A21-866B-4D1F-823E-102951F7F4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2E2F0C2-00F7-4259-97D7-FB686AE940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5EC79ED-CA98-4503-81BA-BF418EDB3E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1B7BE4B-91CB-49DB-B571-01BB1A057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12A2946-AEA0-4A59-92C1-BF7C2FDF7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3450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B50125E-6D28-4FDF-BAA7-4ED54402A1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64A33A2A-2585-41BF-8CA7-27954DF7D3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45A62A79-FAF4-4C7B-AA6D-41ED50DBDF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B2989FB8-071B-44FB-B74F-E6494C986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C142E598-4741-470A-A42D-74AEE4A4E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6CC0075F-7792-41A3-93B5-EB321CC05F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803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078A0F5-1E3C-4A9E-92AB-C06C2AC75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A84DA66-AE9E-4B94-BDEA-BC69DD9FC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9D46FD8F-745D-48C9-8FC4-2DE31EC4DB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4740811-5534-4978-83ED-AD23532034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B201BF62-106D-4102-9E6A-973C6C7EEF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A5841EFE-C882-4EAF-9846-813242DFC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D9A51FE7-F5E2-4641-8FEB-9F9FBF7D0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0CC700ED-59D1-4957-9601-413526C7B3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1186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BD91B69-1229-4E2B-9EBD-069E814F7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E81972AF-1F26-4C10-8C9A-9372F1797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321A4910-C5B4-4D01-95BE-36357259C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EF6FA99-8DC9-411F-8052-44E3B04D9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624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AFE9B00A-EC04-4B97-A484-9A13E9697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0AED63F6-0931-4F6F-A547-622C3C768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9BEDD2CC-58F6-402D-8D2B-0C6967B58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290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747E0E4-7B24-4A42-99EB-E6E49E6CB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BB43A427-8B0B-4CA2-AC62-E792E70065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350D3192-26DD-438B-AEDF-B40625FF21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2BA98524-05F7-4F3A-918B-F5D68876B5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8BF1CD6-5C15-483B-B74E-7EFF7F8760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BD815336-45F8-4303-95A9-21564F779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3535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8084317-7F18-4EA5-BD0B-06ACF589C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F75405C-9EE6-4AB7-B6C3-C61617F7118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6B35DD22-F9BD-4FEE-992C-84779C3505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F484FD8-7B6C-4E75-95EB-826AB3FF1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4FF8E2-CC03-4867-9B2C-167D2A213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FC9F715-4442-446F-B303-3C44A2CE69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5753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7420E905-48DD-4B3D-B9FD-176319F6BC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0A045535-5007-4536-8F4D-B7E3C4638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ABCDA09-D5E8-4BFB-AD9D-88FD0C98C1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9307F-9E56-42DD-AF63-E9D163B60F57}" type="datetimeFigureOut">
              <a:rPr lang="zh-CN" altLang="en-US" smtClean="0"/>
              <a:t>2023/1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3E993E0E-7416-4C02-9128-88125F423EB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379036CF-9D5C-47D5-8794-01D1CCE221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AE25E3-7772-47C4-A391-19374472FC0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19858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8E6A4C7-E288-4861-8ABA-648D0AD90A8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125" y="0"/>
            <a:ext cx="10953750" cy="685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B8CF35D4-0B97-4140-BC45-AE67BA92FDD2}"/>
              </a:ext>
            </a:extLst>
          </p:cNvPr>
          <p:cNvSpPr txBox="1"/>
          <p:nvPr/>
        </p:nvSpPr>
        <p:spPr>
          <a:xfrm>
            <a:off x="7371183" y="2565918"/>
            <a:ext cx="4599993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dditional file 1: </a:t>
            </a:r>
            <a:r>
              <a:rPr lang="en-US" altLang="zh-CN" dirty="0"/>
              <a:t>Figure S1. Assessment of the degradation of </a:t>
            </a:r>
            <a:r>
              <a:rPr lang="en-US" altLang="zh-CN" dirty="0" err="1"/>
              <a:t>autophagosomes</a:t>
            </a:r>
            <a:r>
              <a:rPr lang="en-US" altLang="zh-CN" dirty="0"/>
              <a:t> in gastrocnemius muscle tissue. (A) Immunofluorescence staining of </a:t>
            </a:r>
            <a:r>
              <a:rPr lang="en-US" altLang="zh-CN" dirty="0" err="1"/>
              <a:t>cathepsin</a:t>
            </a:r>
            <a:r>
              <a:rPr lang="en-US" altLang="zh-CN" dirty="0"/>
              <a:t> D. Scale bars = 20 </a:t>
            </a:r>
            <a:r>
              <a:rPr lang="el-GR" altLang="zh-CN" dirty="0"/>
              <a:t>μ</a:t>
            </a:r>
            <a:r>
              <a:rPr lang="en-US" altLang="zh-CN" dirty="0"/>
              <a:t>m. (B) Analysis of </a:t>
            </a:r>
            <a:r>
              <a:rPr lang="en-US" altLang="zh-CN" dirty="0" err="1"/>
              <a:t>immunoreactive</a:t>
            </a:r>
            <a:r>
              <a:rPr lang="en-US" altLang="zh-CN" dirty="0"/>
              <a:t> area of </a:t>
            </a:r>
            <a:r>
              <a:rPr lang="en-US" altLang="zh-CN" dirty="0" err="1"/>
              <a:t>cathepsin</a:t>
            </a:r>
            <a:r>
              <a:rPr lang="en-US" altLang="zh-CN" dirty="0"/>
              <a:t> D (n=15). (C) Representative blots images of mature and intermediate </a:t>
            </a:r>
            <a:r>
              <a:rPr lang="en-US" altLang="zh-CN" dirty="0" err="1"/>
              <a:t>cathepsin</a:t>
            </a:r>
            <a:r>
              <a:rPr lang="en-US" altLang="zh-CN" dirty="0"/>
              <a:t> D and protein expression of </a:t>
            </a:r>
            <a:r>
              <a:rPr lang="en-US" altLang="zh-CN" dirty="0" err="1"/>
              <a:t>cathepsin</a:t>
            </a:r>
            <a:r>
              <a:rPr lang="en-US" altLang="zh-CN" dirty="0"/>
              <a:t> D (n=8). #P &lt; 0.05 vs. Group C, *P &lt; 0.05 vs. Group EE. Exhaustive exercise promotes mature </a:t>
            </a:r>
            <a:r>
              <a:rPr lang="en-US" altLang="zh-CN" dirty="0" err="1"/>
              <a:t>cathepsin</a:t>
            </a:r>
            <a:r>
              <a:rPr lang="en-US" altLang="zh-CN" dirty="0"/>
              <a:t> D expression and </a:t>
            </a:r>
            <a:r>
              <a:rPr lang="en-US" altLang="zh-CN" dirty="0" err="1"/>
              <a:t>autophagosome</a:t>
            </a:r>
            <a:r>
              <a:rPr lang="en-US" altLang="zh-CN" dirty="0"/>
              <a:t> degradation, pre-HIIT inhibits the degradation of </a:t>
            </a:r>
            <a:r>
              <a:rPr lang="en-US" altLang="zh-CN" dirty="0" err="1"/>
              <a:t>autophagosomes</a:t>
            </a:r>
            <a:r>
              <a:rPr lang="en-US" altLang="zh-CN" dirty="0"/>
              <a:t>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23436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BA68EC24-7A3B-4822-9F32-20D6E6C5B5A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6200" y="2286000"/>
            <a:ext cx="4419600" cy="2286000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xmlns="" id="{7CD59114-2524-4E8E-9EC2-09F9CC3AFEFD}"/>
              </a:ext>
            </a:extLst>
          </p:cNvPr>
          <p:cNvSpPr/>
          <p:nvPr/>
        </p:nvSpPr>
        <p:spPr>
          <a:xfrm>
            <a:off x="3243943" y="4725870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altLang="zh-CN"/>
              <a:t>Additional file 1: </a:t>
            </a:r>
            <a:r>
              <a:rPr lang="en-US" altLang="zh-CN" dirty="0"/>
              <a:t>Figure S2. Assessment of exercise performance and muscle injury. (A) Running distance of rats until exhaustion on a treadmill; (B) alterations of plasma CK. Exhaustive exercise induces skeletal muscle injury, pre-HIIT ameliorated skeletal muscle injury and improved the exercise ability of rat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43998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60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等线</vt:lpstr>
      <vt:lpstr>等线 Light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六妹</dc:creator>
  <cp:lastModifiedBy>Jasmine Mohammed Hidayath</cp:lastModifiedBy>
  <cp:revision>2</cp:revision>
  <dcterms:created xsi:type="dcterms:W3CDTF">2023-11-10T05:02:58Z</dcterms:created>
  <dcterms:modified xsi:type="dcterms:W3CDTF">2023-11-11T05:49:49Z</dcterms:modified>
</cp:coreProperties>
</file>